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64B8E7-3DFE-41DD-8A0E-B5923481D7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ABE2CA-47FB-4A9D-B127-5DB7565086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EB9016-A6E0-43F3-B083-8D449BF122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F2AA7-C463-40ED-B632-99EA4A07EE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20B63-6DB8-4B8C-99CE-0AE99D7AB8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E4C3E8-311F-4333-8788-91EF6DDD70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7596B-CD8B-4C54-BDD1-2C09BB1187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748ED6-EF52-43DC-B249-406023362E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5EC5C-3FBF-4A22-A862-E449E9D6B5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8E9341-80BE-43C1-BCF3-B732589FE2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0CE03-F3B3-426D-8259-1D5ABD1892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357516-B74D-43E0-B9B2-BCD1133A1D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99F4CB-D8F6-44B5-A8DC-098769129BD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71280" y="155520"/>
            <a:ext cx="8964720" cy="43531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50920" y="4730760"/>
            <a:ext cx="8604000" cy="202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Figure Legend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(A) 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I</a:t>
            </a:r>
            <a:r>
              <a:rPr b="0" lang="en-GB" sz="1400" spc="-1" strike="noStrike" baseline="-30000">
                <a:solidFill>
                  <a:srgbClr val="000000"/>
                </a:solidFill>
                <a:latin typeface="Times New Roman"/>
                <a:ea typeface="ヒラギノ角ゴ Pro W3"/>
              </a:rPr>
              <a:t>Na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 densities from HEK293 cells transfected with Na</a:t>
            </a:r>
            <a:r>
              <a:rPr b="0" lang="en-GB" sz="1400" spc="-1" strike="noStrike" baseline="-30000">
                <a:solidFill>
                  <a:srgbClr val="000000"/>
                </a:solidFill>
                <a:latin typeface="Times New Roman"/>
                <a:ea typeface="ヒラギノ角ゴ Pro W3"/>
              </a:rPr>
              <a:t>v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1.7 alone, co-transfected with </a:t>
            </a: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β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1-subunit or co-transfected with </a:t>
            </a: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β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1-subunit together with another </a:t>
            </a: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β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-subunit. Student 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t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-tests between control group (Na</a:t>
            </a:r>
            <a:r>
              <a:rPr b="0" lang="en-GB" sz="1400" spc="-1" strike="noStrike" baseline="-30000">
                <a:solidFill>
                  <a:srgbClr val="000000"/>
                </a:solidFill>
                <a:latin typeface="Times New Roman"/>
                <a:ea typeface="ヒラギノ角ゴ Pro W3"/>
              </a:rPr>
              <a:t>v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1.7 alone) and other groups were performed. Data are expressed as mean ± s.e.m. and were normalized to Na</a:t>
            </a:r>
            <a:r>
              <a:rPr b="0" lang="en-GB" sz="1400" spc="-1" strike="noStrike" baseline="-30000">
                <a:solidFill>
                  <a:srgbClr val="000000"/>
                </a:solidFill>
                <a:latin typeface="Times New Roman"/>
                <a:ea typeface="ヒラギノ角ゴ Pro W3"/>
              </a:rPr>
              <a:t>v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1.7 alone for each experiment. (B) 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I</a:t>
            </a:r>
            <a:r>
              <a:rPr b="0" lang="en-GB" sz="1400" spc="-1" strike="noStrike" baseline="-30000">
                <a:solidFill>
                  <a:srgbClr val="000000"/>
                </a:solidFill>
                <a:latin typeface="Times New Roman"/>
                <a:ea typeface="ヒラギノ角ゴ Pro W3"/>
              </a:rPr>
              <a:t>Na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 densities from HEK293 cells transfected with Na</a:t>
            </a:r>
            <a:r>
              <a:rPr b="0" lang="en-GB" sz="1400" spc="-1" strike="noStrike" baseline="-30000">
                <a:solidFill>
                  <a:srgbClr val="000000"/>
                </a:solidFill>
                <a:latin typeface="Times New Roman"/>
                <a:ea typeface="ヒラギノ角ゴ Pro W3"/>
              </a:rPr>
              <a:t>v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1.7 alone, co-transfected with </a:t>
            </a: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β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2-subunit or co-transfected with </a:t>
            </a: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β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2-subunit together with another </a:t>
            </a: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β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-subunit. Student 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t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-tests between control group (Na</a:t>
            </a:r>
            <a:r>
              <a:rPr b="0" lang="en-GB" sz="1400" spc="-1" strike="noStrike" baseline="-30000">
                <a:solidFill>
                  <a:srgbClr val="000000"/>
                </a:solidFill>
                <a:latin typeface="Times New Roman"/>
                <a:ea typeface="ヒラギノ角ゴ Pro W3"/>
              </a:rPr>
              <a:t>v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1.7 alone) and other groups were performed. Data are expressed as mean ± s.e.m. and were normalized to Na</a:t>
            </a:r>
            <a:r>
              <a:rPr b="0" lang="en-GB" sz="1400" spc="-1" strike="noStrike" baseline="-30000">
                <a:solidFill>
                  <a:srgbClr val="000000"/>
                </a:solidFill>
                <a:latin typeface="Times New Roman"/>
                <a:ea typeface="ヒラギノ角ゴ Pro W3"/>
              </a:rPr>
              <a:t>v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ヒラギノ角ゴ Pro W3"/>
              </a:rPr>
              <a:t>1.7 alone for each experiment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23T13:55:20Z</dcterms:created>
  <dc:creator>claederm</dc:creator>
  <dc:description/>
  <dc:language>en-US</dc:language>
  <cp:lastModifiedBy>claederm</cp:lastModifiedBy>
  <dcterms:modified xsi:type="dcterms:W3CDTF">2013-07-23T13:56:06Z</dcterms:modified>
  <cp:revision>1</cp:revision>
  <dc:subject/>
  <dc:title>Diapositiv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